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notesMasterIdLst>
    <p:notesMasterId r:id="rId18"/>
  </p:notesMasterIdLst>
  <p:sldIdLst>
    <p:sldId id="262" r:id="rId6"/>
    <p:sldId id="261" r:id="rId7"/>
    <p:sldId id="257" r:id="rId8"/>
    <p:sldId id="264" r:id="rId9"/>
    <p:sldId id="256" r:id="rId10"/>
    <p:sldId id="266" r:id="rId11"/>
    <p:sldId id="258" r:id="rId12"/>
    <p:sldId id="267" r:id="rId13"/>
    <p:sldId id="259" r:id="rId14"/>
    <p:sldId id="268" r:id="rId15"/>
    <p:sldId id="260" r:id="rId16"/>
    <p:sldId id="269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>
        <p:scale>
          <a:sx n="86" d="100"/>
          <a:sy n="86" d="100"/>
        </p:scale>
        <p:origin x="740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B5DBD9-E5C5-4514-BBBD-6D9DDDA3DCBF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1EC60F-F1EC-4F08-890B-BD8DF1C32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7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3DD5BB-FBAA-47EB-ADAC-E7B8DCBC010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134004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3DD5BB-FBAA-47EB-ADAC-E7B8DCBC010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034981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3DD5BB-FBAA-47EB-ADAC-E7B8DCBC010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04705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3DD5BB-FBAA-47EB-ADAC-E7B8DCBC010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2829217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3DD5BB-FBAA-47EB-ADAC-E7B8DCBC010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64889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201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4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6843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Στυλ κύριου υπότιτλ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2584378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4475952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559064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3761294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51205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4538086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2722277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53750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41011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3794186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3873424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22395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463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29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797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595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051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477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32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BEB17-76F5-4805-8A0A-899CE33FB652}" type="datetimeFigureOut">
              <a:rPr lang="en-US" smtClean="0"/>
              <a:t>7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119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6F0F3-3C53-41BC-8FFD-0BFB6DD91672}" type="datetimeFigureOut">
              <a:rPr lang="el-GR" smtClean="0"/>
              <a:t>19/7/2022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45B6D-1AE9-4C4D-AC38-C455C96DF37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8690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ndreas.koutroulis@odont.uio.no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7" Type="http://schemas.openxmlformats.org/officeDocument/2006/relationships/image" Target="../media/image54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tiff"/><Relationship Id="rId5" Type="http://schemas.openxmlformats.org/officeDocument/2006/relationships/image" Target="../media/image52.tiff"/><Relationship Id="rId4" Type="http://schemas.openxmlformats.org/officeDocument/2006/relationships/image" Target="../media/image51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7" Type="http://schemas.openxmlformats.org/officeDocument/2006/relationships/image" Target="../media/image30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tiff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7" Type="http://schemas.openxmlformats.org/officeDocument/2006/relationships/image" Target="../media/image42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tiff"/><Relationship Id="rId5" Type="http://schemas.openxmlformats.org/officeDocument/2006/relationships/image" Target="../media/image40.tiff"/><Relationship Id="rId4" Type="http://schemas.openxmlformats.org/officeDocument/2006/relationships/image" Target="../media/image3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74776" y="1386713"/>
            <a:ext cx="10515600" cy="4351338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face characteristics and bacterial adhesion of endodontic </a:t>
            </a:r>
            <a:r>
              <a:rPr lang="en-US" sz="2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ments 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inical Oral Investigations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utrouli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.V.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kk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Ørstavik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ralo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milleri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T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nde</a:t>
            </a:r>
            <a:endParaRPr lang="nb-NO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en-US" sz="1200" dirty="0">
                <a:latin typeface="Times New Roman" panose="02020603050405020304" pitchFamily="18" charset="0"/>
              </a:rPr>
              <a:t>Section of Endodontics, Institute of Clinical Dentistry, Faculty of Dentistry, University of </a:t>
            </a:r>
            <a:r>
              <a:rPr lang="en-US" sz="1200" dirty="0" smtClean="0">
                <a:latin typeface="Times New Roman" panose="02020603050405020304" pitchFamily="18" charset="0"/>
              </a:rPr>
              <a:t>Oslo, Oslo, Norway</a:t>
            </a:r>
            <a:endParaRPr lang="nb-NO" sz="1200" dirty="0"/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mail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ress: </a:t>
            </a:r>
            <a:r>
              <a:rPr lang="en-US" sz="1200" u="sng" dirty="0">
                <a:solidFill>
                  <a:srgbClr val="0563C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andreas.koutroulis@odont.uio.no</a:t>
            </a:r>
            <a:endParaRPr lang="nb-NO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800"/>
              </a:spcAft>
            </a:pPr>
            <a:endParaRPr lang="nb-NO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7548640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58800" y="414000"/>
            <a:ext cx="8425568" cy="4939808"/>
            <a:chOff x="798423" y="1696456"/>
            <a:chExt cx="8425568" cy="4939808"/>
          </a:xfrm>
        </p:grpSpPr>
        <p:grpSp>
          <p:nvGrpSpPr>
            <p:cNvPr id="15" name="Group 14"/>
            <p:cNvGrpSpPr/>
            <p:nvPr/>
          </p:nvGrpSpPr>
          <p:grpSpPr>
            <a:xfrm>
              <a:off x="798423" y="2096815"/>
              <a:ext cx="8425568" cy="4539449"/>
              <a:chOff x="327907" y="294648"/>
              <a:chExt cx="8425568" cy="4539449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1540638" y="298800"/>
                <a:ext cx="18475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63078" y="298800"/>
                <a:ext cx="18477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7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573850" y="298800"/>
                <a:ext cx="1850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8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27907" y="1406133"/>
                <a:ext cx="654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ater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42194" y="3367065"/>
                <a:ext cx="4899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B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3842883" y="294648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6271540" y="295200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" name="Group 1"/>
              <p:cNvGrpSpPr/>
              <p:nvPr/>
            </p:nvGrpSpPr>
            <p:grpSpPr>
              <a:xfrm>
                <a:off x="1508825" y="666450"/>
                <a:ext cx="2239460" cy="2081774"/>
                <a:chOff x="1508825" y="666450"/>
                <a:chExt cx="2239460" cy="2081774"/>
              </a:xfrm>
            </p:grpSpPr>
            <p:pic>
              <p:nvPicPr>
                <p:cNvPr id="3" name="Εικόνα 3">
                  <a:extLst>
                    <a:ext uri="{FF2B5EF4-FFF2-40B4-BE49-F238E27FC236}">
                      <a16:creationId xmlns:a16="http://schemas.microsoft.com/office/drawing/2014/main" id="{18D83104-913C-0934-2F10-C0DC4AF560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59092" r="75694" b="296"/>
                <a:stretch/>
              </p:blipFill>
              <p:spPr>
                <a:xfrm>
                  <a:off x="1508825" y="832917"/>
                  <a:ext cx="2239460" cy="1915307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1737447" y="666450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851852" y="2418661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3886200" y="732257"/>
                <a:ext cx="2266957" cy="2015967"/>
                <a:chOff x="3886200" y="732257"/>
                <a:chExt cx="2266957" cy="2015967"/>
              </a:xfrm>
            </p:grpSpPr>
            <p:pic>
              <p:nvPicPr>
                <p:cNvPr id="4" name="Εικόνα 4">
                  <a:extLst>
                    <a:ext uri="{FF2B5EF4-FFF2-40B4-BE49-F238E27FC236}">
                      <a16:creationId xmlns:a16="http://schemas.microsoft.com/office/drawing/2014/main" id="{08FC0048-B157-22C3-B484-EEDE7F45852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t="65185" r="76985" b="247"/>
                <a:stretch/>
              </p:blipFill>
              <p:spPr>
                <a:xfrm>
                  <a:off x="3886200" y="881894"/>
                  <a:ext cx="2266957" cy="1866330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4135396" y="732257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5216857" y="2381814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6315751" y="695452"/>
                <a:ext cx="2156746" cy="2028284"/>
                <a:chOff x="6315751" y="695452"/>
                <a:chExt cx="2156746" cy="2028284"/>
              </a:xfrm>
            </p:grpSpPr>
            <p:pic>
              <p:nvPicPr>
                <p:cNvPr id="5" name="Εικόνα 6">
                  <a:extLst>
                    <a:ext uri="{FF2B5EF4-FFF2-40B4-BE49-F238E27FC236}">
                      <a16:creationId xmlns:a16="http://schemas.microsoft.com/office/drawing/2014/main" id="{4F23070E-5100-B534-319C-BB0E034186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65394" r="78195" b="254"/>
                <a:stretch/>
              </p:blipFill>
              <p:spPr>
                <a:xfrm>
                  <a:off x="6315751" y="857404"/>
                  <a:ext cx="2156746" cy="1866332"/>
                </a:xfrm>
                <a:prstGeom prst="rect">
                  <a:avLst/>
                </a:prstGeom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>
                  <a:off x="6566788" y="695452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7613664" y="2365854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1567759" y="2773788"/>
                <a:ext cx="2156741" cy="2024066"/>
                <a:chOff x="1567759" y="2773788"/>
                <a:chExt cx="2156741" cy="2024066"/>
              </a:xfrm>
            </p:grpSpPr>
            <p:pic>
              <p:nvPicPr>
                <p:cNvPr id="10" name="Εικόνα 11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4F1C7865-0EA1-FDA7-DBCA-2020C8A802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t="58944" r="74053" b="293"/>
                <a:stretch/>
              </p:blipFill>
              <p:spPr>
                <a:xfrm>
                  <a:off x="1567759" y="2931626"/>
                  <a:ext cx="2156741" cy="1866228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1760159" y="2773788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831541" y="447420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3937482" y="2849340"/>
                <a:ext cx="2090069" cy="1984757"/>
                <a:chOff x="3937482" y="2849340"/>
                <a:chExt cx="2090069" cy="1984757"/>
              </a:xfrm>
            </p:grpSpPr>
            <p:pic>
              <p:nvPicPr>
                <p:cNvPr id="14" name="Εικόνα 14">
                  <a:extLst>
                    <a:ext uri="{FF2B5EF4-FFF2-40B4-BE49-F238E27FC236}">
                      <a16:creationId xmlns:a16="http://schemas.microsoft.com/office/drawing/2014/main" id="{41A35863-0440-95F0-AA76-8E7F061F60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63388" r="75795" b="-273"/>
                <a:stretch/>
              </p:blipFill>
              <p:spPr>
                <a:xfrm>
                  <a:off x="3937482" y="3003239"/>
                  <a:ext cx="2090069" cy="1830858"/>
                </a:xfrm>
                <a:prstGeom prst="rect">
                  <a:avLst/>
                </a:prstGeom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4149974" y="2849340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5140851" y="449614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6389924" y="2729662"/>
                <a:ext cx="2139990" cy="2028457"/>
                <a:chOff x="6389924" y="2729662"/>
                <a:chExt cx="2139990" cy="2028457"/>
              </a:xfrm>
            </p:grpSpPr>
            <p:pic>
              <p:nvPicPr>
                <p:cNvPr id="13" name="Εικόνα 13">
                  <a:extLst>
                    <a:ext uri="{FF2B5EF4-FFF2-40B4-BE49-F238E27FC236}">
                      <a16:creationId xmlns:a16="http://schemas.microsoft.com/office/drawing/2014/main" id="{FC5220CB-6AB9-FBA2-CA03-0266EEE643E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t="56379" r="72881" b="605"/>
                <a:stretch/>
              </p:blipFill>
              <p:spPr>
                <a:xfrm>
                  <a:off x="6389924" y="2881510"/>
                  <a:ext cx="2139990" cy="1876609"/>
                </a:xfrm>
                <a:prstGeom prst="rect">
                  <a:avLst/>
                </a:prstGeom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6580397" y="2729662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7611507" y="449614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4" name="Straight Connector 43"/>
              <p:cNvCxnSpPr/>
              <p:nvPr/>
            </p:nvCxnSpPr>
            <p:spPr>
              <a:xfrm>
                <a:off x="1057452" y="2629815"/>
                <a:ext cx="769602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>
              <a:off x="2647998" y="1696456"/>
              <a:ext cx="56843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Z-Ag0.5</a:t>
              </a:r>
              <a:endPara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036059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92400" y="1083600"/>
            <a:ext cx="6193167" cy="3301949"/>
            <a:chOff x="162000" y="504000"/>
            <a:chExt cx="6193167" cy="3301949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0944" y="2401949"/>
              <a:ext cx="1872000" cy="1404000"/>
            </a:xfrm>
            <a:prstGeom prst="rect">
              <a:avLst/>
            </a:prstGeom>
          </p:spPr>
        </p:pic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162000" y="504000"/>
              <a:ext cx="6193167" cy="3301949"/>
              <a:chOff x="-114915" y="289091"/>
              <a:chExt cx="10031716" cy="5348509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9600" y="1026000"/>
                <a:ext cx="3033599" cy="227520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33624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3362400"/>
                <a:ext cx="3033600" cy="2275200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704754" y="640676"/>
                <a:ext cx="3030844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Day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787199" y="635177"/>
                <a:ext cx="3037200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872399" y="652764"/>
                <a:ext cx="3044402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-114915" y="2008613"/>
                <a:ext cx="919359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r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0" y="4347530"/>
                <a:ext cx="804442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B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05600" y="289091"/>
                <a:ext cx="9207600" cy="498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Z-Ag1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74861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58800" y="414000"/>
            <a:ext cx="8425568" cy="5163471"/>
            <a:chOff x="1082650" y="511136"/>
            <a:chExt cx="8425568" cy="5163471"/>
          </a:xfrm>
        </p:grpSpPr>
        <p:grpSp>
          <p:nvGrpSpPr>
            <p:cNvPr id="13" name="Group 12"/>
            <p:cNvGrpSpPr/>
            <p:nvPr/>
          </p:nvGrpSpPr>
          <p:grpSpPr>
            <a:xfrm>
              <a:off x="1082650" y="984076"/>
              <a:ext cx="8425568" cy="4690531"/>
              <a:chOff x="327907" y="294648"/>
              <a:chExt cx="8425568" cy="4690531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1540638" y="298800"/>
                <a:ext cx="18475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63078" y="298800"/>
                <a:ext cx="18477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7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573850" y="298800"/>
                <a:ext cx="1850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8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27907" y="1406133"/>
                <a:ext cx="654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ater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42194" y="3367065"/>
                <a:ext cx="4899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B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Straight Connector 51"/>
              <p:cNvCxnSpPr/>
              <p:nvPr/>
            </p:nvCxnSpPr>
            <p:spPr>
              <a:xfrm>
                <a:off x="6271540" y="295200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" name="Group 7"/>
              <p:cNvGrpSpPr/>
              <p:nvPr/>
            </p:nvGrpSpPr>
            <p:grpSpPr>
              <a:xfrm>
                <a:off x="1409700" y="566191"/>
                <a:ext cx="2247906" cy="2144163"/>
                <a:chOff x="1409700" y="566191"/>
                <a:chExt cx="2247906" cy="2144163"/>
              </a:xfrm>
            </p:grpSpPr>
            <p:pic>
              <p:nvPicPr>
                <p:cNvPr id="3" name="Εικόνα 3">
                  <a:extLst>
                    <a:ext uri="{FF2B5EF4-FFF2-40B4-BE49-F238E27FC236}">
                      <a16:creationId xmlns:a16="http://schemas.microsoft.com/office/drawing/2014/main" id="{54CF0D0B-A882-3A24-EFAB-0DCE7C0BC9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59594" r="76413" b="239"/>
                <a:stretch/>
              </p:blipFill>
              <p:spPr>
                <a:xfrm>
                  <a:off x="1409700" y="728237"/>
                  <a:ext cx="2247906" cy="1982117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1653186" y="566191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777998" y="2366372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3819525" y="610433"/>
                <a:ext cx="2337719" cy="2109599"/>
                <a:chOff x="3819525" y="610433"/>
                <a:chExt cx="2337719" cy="2109599"/>
              </a:xfrm>
            </p:grpSpPr>
            <p:pic>
              <p:nvPicPr>
                <p:cNvPr id="7" name="Εικόνα 9">
                  <a:extLst>
                    <a:ext uri="{FF2B5EF4-FFF2-40B4-BE49-F238E27FC236}">
                      <a16:creationId xmlns:a16="http://schemas.microsoft.com/office/drawing/2014/main" id="{B6089D67-D3A8-CE4F-F20F-45FFC797E6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t="62740" r="77090" b="274"/>
                <a:stretch/>
              </p:blipFill>
              <p:spPr>
                <a:xfrm>
                  <a:off x="3819525" y="788271"/>
                  <a:ext cx="2337719" cy="1931761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4084561" y="610433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5240279" y="2360646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Group 4"/>
              <p:cNvGrpSpPr/>
              <p:nvPr/>
            </p:nvGrpSpPr>
            <p:grpSpPr>
              <a:xfrm>
                <a:off x="1457325" y="2722303"/>
                <a:ext cx="2085978" cy="2120747"/>
                <a:chOff x="1457325" y="2722303"/>
                <a:chExt cx="2085978" cy="2120747"/>
              </a:xfrm>
            </p:grpSpPr>
            <p:pic>
              <p:nvPicPr>
                <p:cNvPr id="12" name="Εικόνα 12">
                  <a:extLst>
                    <a:ext uri="{FF2B5EF4-FFF2-40B4-BE49-F238E27FC236}">
                      <a16:creationId xmlns:a16="http://schemas.microsoft.com/office/drawing/2014/main" id="{7BAFDD0A-4B47-8E42-88C4-9FC6CD8E8C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57767" r="73955" b="-243"/>
                <a:stretch/>
              </p:blipFill>
              <p:spPr>
                <a:xfrm>
                  <a:off x="1457325" y="2907104"/>
                  <a:ext cx="2085978" cy="1935946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1653186" y="2722303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680603" y="4536638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" name="Group 3"/>
              <p:cNvGrpSpPr/>
              <p:nvPr/>
            </p:nvGrpSpPr>
            <p:grpSpPr>
              <a:xfrm>
                <a:off x="3838575" y="2830025"/>
                <a:ext cx="2286003" cy="2126716"/>
                <a:chOff x="3838575" y="2830025"/>
                <a:chExt cx="2286003" cy="2126716"/>
              </a:xfrm>
            </p:grpSpPr>
            <p:pic>
              <p:nvPicPr>
                <p:cNvPr id="14" name="Εικόνα 14">
                  <a:extLst>
                    <a:ext uri="{FF2B5EF4-FFF2-40B4-BE49-F238E27FC236}">
                      <a16:creationId xmlns:a16="http://schemas.microsoft.com/office/drawing/2014/main" id="{45610827-D19B-32F2-C3F2-F81EA9D87F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t="68653" r="77612" b="-259"/>
                <a:stretch/>
              </p:blipFill>
              <p:spPr>
                <a:xfrm>
                  <a:off x="3838575" y="3021404"/>
                  <a:ext cx="2286003" cy="1935337"/>
                </a:xfrm>
                <a:prstGeom prst="rect">
                  <a:avLst/>
                </a:prstGeom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4084561" y="2830025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5213602" y="454267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Group 1"/>
              <p:cNvGrpSpPr/>
              <p:nvPr/>
            </p:nvGrpSpPr>
            <p:grpSpPr>
              <a:xfrm>
                <a:off x="6315075" y="2821490"/>
                <a:ext cx="2266952" cy="2163689"/>
                <a:chOff x="6315075" y="2821490"/>
                <a:chExt cx="2266952" cy="2163689"/>
              </a:xfrm>
            </p:grpSpPr>
            <p:pic>
              <p:nvPicPr>
                <p:cNvPr id="15" name="Εικόνα 15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530EBE33-3394-16E3-2F75-19AA37FE991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71223" r="80498" b="-360"/>
                <a:stretch/>
              </p:blipFill>
              <p:spPr>
                <a:xfrm>
                  <a:off x="6315075" y="3011879"/>
                  <a:ext cx="2266952" cy="1973300"/>
                </a:xfrm>
                <a:prstGeom prst="rect">
                  <a:avLst/>
                </a:prstGeom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6658808" y="2821490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7688607" y="454267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9" name="Straight Connector 48"/>
              <p:cNvCxnSpPr/>
              <p:nvPr/>
            </p:nvCxnSpPr>
            <p:spPr>
              <a:xfrm>
                <a:off x="3842883" y="294648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" name="Group 10"/>
              <p:cNvGrpSpPr/>
              <p:nvPr/>
            </p:nvGrpSpPr>
            <p:grpSpPr>
              <a:xfrm>
                <a:off x="6429375" y="601335"/>
                <a:ext cx="2219328" cy="2080218"/>
                <a:chOff x="6429375" y="601335"/>
                <a:chExt cx="2219328" cy="2080218"/>
              </a:xfrm>
            </p:grpSpPr>
            <p:pic>
              <p:nvPicPr>
                <p:cNvPr id="10" name="Εικόνα 11">
                  <a:extLst>
                    <a:ext uri="{FF2B5EF4-FFF2-40B4-BE49-F238E27FC236}">
                      <a16:creationId xmlns:a16="http://schemas.microsoft.com/office/drawing/2014/main" id="{9C4E23BD-707C-1205-D1C7-D33E074E76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t="65426" r="78017" b="266"/>
                <a:stretch/>
              </p:blipFill>
              <p:spPr>
                <a:xfrm>
                  <a:off x="6429375" y="786644"/>
                  <a:ext cx="2219328" cy="1894909"/>
                </a:xfrm>
                <a:prstGeom prst="rect">
                  <a:avLst/>
                </a:prstGeom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>
                  <a:off x="6691474" y="601335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7721273" y="2322844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4" name="Straight Connector 43"/>
              <p:cNvCxnSpPr/>
              <p:nvPr/>
            </p:nvCxnSpPr>
            <p:spPr>
              <a:xfrm>
                <a:off x="1057452" y="2629815"/>
                <a:ext cx="769602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>
              <a:off x="2900931" y="511136"/>
              <a:ext cx="56843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Z-Ag1</a:t>
              </a:r>
              <a:endPara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64374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1255" y="1357745"/>
            <a:ext cx="10515600" cy="1718397"/>
          </a:xfrm>
        </p:spPr>
        <p:txBody>
          <a:bodyPr>
            <a:no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scanning electro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gaph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rototype materials acquired with a mix of back-scatter and secondary electron signal detectors (1500× magnification) after exposure to ultrapure water (water) or Fetal Bovine Serum (FBS) for 1, 7 or 28 days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9535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193946" y="1083972"/>
            <a:ext cx="6160641" cy="3327049"/>
            <a:chOff x="163327" y="503351"/>
            <a:chExt cx="6160641" cy="3327049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5200" y="2425881"/>
              <a:ext cx="1872000" cy="1404000"/>
            </a:xfrm>
            <a:prstGeom prst="rect">
              <a:avLst/>
            </a:prstGeom>
          </p:spPr>
        </p:pic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163327" y="503351"/>
              <a:ext cx="6160641" cy="3326530"/>
              <a:chOff x="-65829" y="249274"/>
              <a:chExt cx="9979030" cy="5388326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96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3362400"/>
                <a:ext cx="3033600" cy="2275200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4579950" y="249274"/>
                <a:ext cx="1614115" cy="498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Z-base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05600" y="648386"/>
                <a:ext cx="3029999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Day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790799" y="648384"/>
                <a:ext cx="3033599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876001" y="648384"/>
                <a:ext cx="3037200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-65829" y="2008613"/>
                <a:ext cx="870270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r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0" y="4347530"/>
                <a:ext cx="804442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B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8925" y="2426400"/>
              <a:ext cx="1872000" cy="1404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964634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658107" y="412244"/>
            <a:ext cx="8425568" cy="4939949"/>
            <a:chOff x="658107" y="412244"/>
            <a:chExt cx="8425568" cy="4939949"/>
          </a:xfrm>
        </p:grpSpPr>
        <p:grpSp>
          <p:nvGrpSpPr>
            <p:cNvPr id="12" name="Group 11"/>
            <p:cNvGrpSpPr/>
            <p:nvPr/>
          </p:nvGrpSpPr>
          <p:grpSpPr>
            <a:xfrm>
              <a:off x="658107" y="840748"/>
              <a:ext cx="8425568" cy="4511445"/>
              <a:chOff x="327907" y="294648"/>
              <a:chExt cx="8425568" cy="4511445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1540638" y="298800"/>
                <a:ext cx="18475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63078" y="298800"/>
                <a:ext cx="18477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7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573850" y="298800"/>
                <a:ext cx="1850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8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27907" y="1406133"/>
                <a:ext cx="654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ater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42194" y="3367065"/>
                <a:ext cx="4899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B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3842883" y="294648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" name="Group 9"/>
              <p:cNvGrpSpPr/>
              <p:nvPr/>
            </p:nvGrpSpPr>
            <p:grpSpPr>
              <a:xfrm>
                <a:off x="6177631" y="734846"/>
                <a:ext cx="2503977" cy="2035823"/>
                <a:chOff x="6177631" y="734846"/>
                <a:chExt cx="2503977" cy="2035823"/>
              </a:xfrm>
            </p:grpSpPr>
            <p:pic>
              <p:nvPicPr>
                <p:cNvPr id="21" name="Εικόνα 21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CF6159F3-1B73-0048-4F67-ED478D09612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65965" r="76078" b="284"/>
                <a:stretch/>
              </p:blipFill>
              <p:spPr>
                <a:xfrm>
                  <a:off x="6177631" y="894476"/>
                  <a:ext cx="2503977" cy="1876193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6456878" y="734846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7716336" y="2414371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Group 4"/>
              <p:cNvGrpSpPr/>
              <p:nvPr/>
            </p:nvGrpSpPr>
            <p:grpSpPr>
              <a:xfrm>
                <a:off x="1333650" y="468077"/>
                <a:ext cx="2455956" cy="2289340"/>
                <a:chOff x="1333650" y="468077"/>
                <a:chExt cx="2455956" cy="2289340"/>
              </a:xfrm>
            </p:grpSpPr>
            <p:pic>
              <p:nvPicPr>
                <p:cNvPr id="25" name="Εικόνα 25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526497E8-EDD9-4659-D7EF-AB2E9D2D70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t="57669" r="75710" b="275"/>
                <a:stretch/>
              </p:blipFill>
              <p:spPr>
                <a:xfrm>
                  <a:off x="1333650" y="601159"/>
                  <a:ext cx="2455956" cy="2156258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1591564" y="468077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2811995" y="2394492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3885025" y="645937"/>
                <a:ext cx="2292606" cy="2111480"/>
                <a:chOff x="3885025" y="645937"/>
                <a:chExt cx="2292606" cy="2111480"/>
              </a:xfrm>
            </p:grpSpPr>
            <p:pic>
              <p:nvPicPr>
                <p:cNvPr id="24" name="Εικόνα 24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6CC4F8CA-9182-7CEB-0674-5FD1F56DF3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46" t="60396" r="76148" b="248"/>
                <a:stretch/>
              </p:blipFill>
              <p:spPr>
                <a:xfrm>
                  <a:off x="3885025" y="798726"/>
                  <a:ext cx="2292606" cy="1958691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4109885" y="645937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5242935" y="2406888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" name="Group 3"/>
              <p:cNvGrpSpPr/>
              <p:nvPr/>
            </p:nvGrpSpPr>
            <p:grpSpPr>
              <a:xfrm>
                <a:off x="1432816" y="2857966"/>
                <a:ext cx="2166959" cy="1891892"/>
                <a:chOff x="1432816" y="2857966"/>
                <a:chExt cx="2166959" cy="1891892"/>
              </a:xfrm>
            </p:grpSpPr>
            <p:pic>
              <p:nvPicPr>
                <p:cNvPr id="11" name="Εικόνα 11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9E34164E-CACB-5439-8812-74BA3ED28F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t="57176" r="72043" b="-232"/>
                <a:stretch/>
              </p:blipFill>
              <p:spPr>
                <a:xfrm>
                  <a:off x="1432816" y="3026229"/>
                  <a:ext cx="2166959" cy="1723629"/>
                </a:xfrm>
                <a:prstGeom prst="rect">
                  <a:avLst/>
                </a:prstGeom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1624982" y="2857966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2706558" y="4443028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" name="Group 2"/>
              <p:cNvGrpSpPr/>
              <p:nvPr/>
            </p:nvGrpSpPr>
            <p:grpSpPr>
              <a:xfrm>
                <a:off x="3885025" y="2807675"/>
                <a:ext cx="2091595" cy="1998418"/>
                <a:chOff x="3885025" y="2807675"/>
                <a:chExt cx="2091595" cy="1998418"/>
              </a:xfrm>
            </p:grpSpPr>
            <p:pic>
              <p:nvPicPr>
                <p:cNvPr id="9" name="Εικόνα 9">
                  <a:extLst>
                    <a:ext uri="{FF2B5EF4-FFF2-40B4-BE49-F238E27FC236}">
                      <a16:creationId xmlns:a16="http://schemas.microsoft.com/office/drawing/2014/main" id="{16476B52-28C8-57A7-C6D9-8C6C413A7A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59963" r="76369" b="-186"/>
                <a:stretch/>
              </p:blipFill>
              <p:spPr>
                <a:xfrm>
                  <a:off x="3885025" y="2969993"/>
                  <a:ext cx="2091595" cy="1836100"/>
                </a:xfrm>
                <a:prstGeom prst="rect">
                  <a:avLst/>
                </a:prstGeom>
              </p:spPr>
            </p:pic>
            <p:sp>
              <p:nvSpPr>
                <p:cNvPr id="26" name="TextBox 25"/>
                <p:cNvSpPr txBox="1"/>
                <p:nvPr/>
              </p:nvSpPr>
              <p:spPr>
                <a:xfrm>
                  <a:off x="4108629" y="2807675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5112203" y="4468388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Group 1"/>
              <p:cNvGrpSpPr/>
              <p:nvPr/>
            </p:nvGrpSpPr>
            <p:grpSpPr>
              <a:xfrm>
                <a:off x="6337294" y="3091398"/>
                <a:ext cx="2190480" cy="1658460"/>
                <a:chOff x="6337294" y="3091398"/>
                <a:chExt cx="2190480" cy="1658460"/>
              </a:xfrm>
            </p:grpSpPr>
            <p:pic>
              <p:nvPicPr>
                <p:cNvPr id="8" name="Εικόνα 8">
                  <a:extLst>
                    <a:ext uri="{FF2B5EF4-FFF2-40B4-BE49-F238E27FC236}">
                      <a16:creationId xmlns:a16="http://schemas.microsoft.com/office/drawing/2014/main" id="{E7C34E8C-AF3F-7910-00CD-F832C0CC99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t="67876" r="75636" b="-259"/>
                <a:stretch/>
              </p:blipFill>
              <p:spPr>
                <a:xfrm>
                  <a:off x="6337294" y="3246957"/>
                  <a:ext cx="2190480" cy="1502901"/>
                </a:xfrm>
                <a:prstGeom prst="rect">
                  <a:avLst/>
                </a:prstGeom>
              </p:spPr>
            </p:pic>
            <p:sp>
              <p:nvSpPr>
                <p:cNvPr id="27" name="TextBox 26"/>
                <p:cNvSpPr txBox="1"/>
                <p:nvPr/>
              </p:nvSpPr>
              <p:spPr>
                <a:xfrm>
                  <a:off x="6580219" y="3091398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7638531" y="4419946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4" name="Straight Connector 43"/>
              <p:cNvCxnSpPr/>
              <p:nvPr/>
            </p:nvCxnSpPr>
            <p:spPr>
              <a:xfrm>
                <a:off x="1057452" y="2629815"/>
                <a:ext cx="769602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6271540" y="295200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4818928" y="412244"/>
              <a:ext cx="9964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Z-base</a:t>
              </a:r>
              <a:endPara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9197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192400" y="1083600"/>
            <a:ext cx="6163090" cy="3305194"/>
            <a:chOff x="-69797" y="283835"/>
            <a:chExt cx="9982997" cy="5353765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5600" y="3362400"/>
              <a:ext cx="3033601" cy="22752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0800" y="3362400"/>
              <a:ext cx="3033600" cy="22752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79600" y="3362400"/>
              <a:ext cx="3033600" cy="227520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5600" y="1026000"/>
              <a:ext cx="3033601" cy="22752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79600" y="1026000"/>
              <a:ext cx="3033600" cy="227520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0800" y="1026000"/>
              <a:ext cx="3033600" cy="227520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705600" y="657878"/>
              <a:ext cx="3029999" cy="448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Day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787199" y="657878"/>
              <a:ext cx="3037200" cy="448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 Day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872397" y="657878"/>
              <a:ext cx="3040801" cy="448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 Day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-69797" y="2008613"/>
              <a:ext cx="874239" cy="398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nb-NO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er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0" y="4347530"/>
              <a:ext cx="804442" cy="398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B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05600" y="283835"/>
              <a:ext cx="9207600" cy="49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Z-bg10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609934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58800" y="414000"/>
            <a:ext cx="8425568" cy="5026539"/>
            <a:chOff x="2021534" y="372608"/>
            <a:chExt cx="8425568" cy="5026539"/>
          </a:xfrm>
        </p:grpSpPr>
        <p:grpSp>
          <p:nvGrpSpPr>
            <p:cNvPr id="15" name="Group 14"/>
            <p:cNvGrpSpPr/>
            <p:nvPr/>
          </p:nvGrpSpPr>
          <p:grpSpPr>
            <a:xfrm>
              <a:off x="2021534" y="852542"/>
              <a:ext cx="8425568" cy="4546605"/>
              <a:chOff x="327907" y="288000"/>
              <a:chExt cx="8425568" cy="4546605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1540638" y="288000"/>
                <a:ext cx="18475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63078" y="288000"/>
                <a:ext cx="18477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7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573850" y="288000"/>
                <a:ext cx="1850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8 </a:t>
                </a:r>
                <a:r>
                  <a:rPr kumimoji="0" lang="nb-NO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27907" y="1406133"/>
                <a:ext cx="654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ater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42194" y="3367065"/>
                <a:ext cx="4899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BS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3842883" y="294648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" name="Group 7"/>
              <p:cNvGrpSpPr/>
              <p:nvPr/>
            </p:nvGrpSpPr>
            <p:grpSpPr>
              <a:xfrm>
                <a:off x="1527774" y="505572"/>
                <a:ext cx="2117739" cy="2128796"/>
                <a:chOff x="1527774" y="505572"/>
                <a:chExt cx="2117739" cy="2128796"/>
              </a:xfrm>
            </p:grpSpPr>
            <p:pic>
              <p:nvPicPr>
                <p:cNvPr id="4" name="Εικόνα 4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ED49727A-C74D-4FC2-591A-A234BE6B0A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46957" r="72197" b="290"/>
                <a:stretch/>
              </p:blipFill>
              <p:spPr>
                <a:xfrm>
                  <a:off x="1527774" y="636710"/>
                  <a:ext cx="2117739" cy="1997658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1705586" y="505572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804848" y="2368514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3859309" y="485742"/>
                <a:ext cx="2316181" cy="2206186"/>
                <a:chOff x="3859309" y="485742"/>
                <a:chExt cx="2316181" cy="2206186"/>
              </a:xfrm>
            </p:grpSpPr>
            <p:pic>
              <p:nvPicPr>
                <p:cNvPr id="5" name="Εικόνα 6">
                  <a:extLst>
                    <a:ext uri="{FF2B5EF4-FFF2-40B4-BE49-F238E27FC236}">
                      <a16:creationId xmlns:a16="http://schemas.microsoft.com/office/drawing/2014/main" id="{34FDA0BD-49D3-40D4-DE00-2B68DD8475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t="55270" r="74214" b="257"/>
                <a:stretch/>
              </p:blipFill>
              <p:spPr>
                <a:xfrm>
                  <a:off x="3859309" y="636710"/>
                  <a:ext cx="2316181" cy="2055218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4095507" y="485742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5280509" y="2364538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6364168" y="505572"/>
                <a:ext cx="2239978" cy="2167290"/>
                <a:chOff x="6364168" y="505572"/>
                <a:chExt cx="2239978" cy="2167290"/>
              </a:xfrm>
            </p:grpSpPr>
            <p:pic>
              <p:nvPicPr>
                <p:cNvPr id="7" name="Εικόνα 9">
                  <a:extLst>
                    <a:ext uri="{FF2B5EF4-FFF2-40B4-BE49-F238E27FC236}">
                      <a16:creationId xmlns:a16="http://schemas.microsoft.com/office/drawing/2014/main" id="{0094BB58-50D2-1E16-B7C9-FEC97CA80F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54663" r="74111" b="259"/>
                <a:stretch/>
              </p:blipFill>
              <p:spPr>
                <a:xfrm>
                  <a:off x="6364168" y="655775"/>
                  <a:ext cx="2239978" cy="2017087"/>
                </a:xfrm>
                <a:prstGeom prst="rect">
                  <a:avLst/>
                </a:prstGeom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>
                  <a:off x="6597501" y="505572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7728573" y="2359956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1540638" y="2668770"/>
                <a:ext cx="1999936" cy="2065943"/>
                <a:chOff x="1540638" y="2668770"/>
                <a:chExt cx="1999936" cy="2065943"/>
              </a:xfrm>
            </p:grpSpPr>
            <p:pic>
              <p:nvPicPr>
                <p:cNvPr id="12" name="Εικόνα 12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ECCCBE3C-C33C-E9F7-1685-C5267635B3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t="52553" r="74454" b="213"/>
                <a:stretch/>
              </p:blipFill>
              <p:spPr>
                <a:xfrm>
                  <a:off x="1540638" y="2844045"/>
                  <a:ext cx="1999936" cy="1890668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1720496" y="2668770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697167" y="4434869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3914992" y="2691928"/>
                <a:ext cx="2130123" cy="2022952"/>
                <a:chOff x="3914992" y="2691928"/>
                <a:chExt cx="2130123" cy="2022952"/>
              </a:xfrm>
            </p:grpSpPr>
            <p:pic>
              <p:nvPicPr>
                <p:cNvPr id="3" name="Εικόνα 3" descr="Εικόνα που περιέχει πίνακας&#10;&#10;Περιγραφή που δημιουργήθηκε αυτόματα">
                  <a:extLst>
                    <a:ext uri="{FF2B5EF4-FFF2-40B4-BE49-F238E27FC236}">
                      <a16:creationId xmlns:a16="http://schemas.microsoft.com/office/drawing/2014/main" id="{F6FF3A96-DCE1-CFFA-6D54-4564964623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51373" r="72687" b="316"/>
                <a:stretch/>
              </p:blipFill>
              <p:spPr>
                <a:xfrm>
                  <a:off x="3914992" y="2816844"/>
                  <a:ext cx="2130122" cy="1898036"/>
                </a:xfrm>
                <a:prstGeom prst="rect">
                  <a:avLst/>
                </a:prstGeom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4102907" y="2691928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5234421" y="4437645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6271540" y="2693381"/>
                <a:ext cx="2221740" cy="2141224"/>
                <a:chOff x="6271540" y="2693381"/>
                <a:chExt cx="2221740" cy="2141224"/>
              </a:xfrm>
            </p:grpSpPr>
            <p:pic>
              <p:nvPicPr>
                <p:cNvPr id="2" name="Εικόνα 7">
                  <a:extLst>
                    <a:ext uri="{FF2B5EF4-FFF2-40B4-BE49-F238E27FC236}">
                      <a16:creationId xmlns:a16="http://schemas.microsoft.com/office/drawing/2014/main" id="{8D95C1F5-20D2-492E-90B6-24D612FB9A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t="66667" r="79663" b="206"/>
                <a:stretch/>
              </p:blipFill>
              <p:spPr>
                <a:xfrm>
                  <a:off x="6271540" y="2858171"/>
                  <a:ext cx="2221740" cy="1976434"/>
                </a:xfrm>
                <a:prstGeom prst="rect">
                  <a:avLst/>
                </a:prstGeom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6563910" y="2693381"/>
                  <a:ext cx="62295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ps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Ev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7599617" y="4450523"/>
                  <a:ext cx="81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ergy [</a:t>
                  </a:r>
                  <a:r>
                    <a:rPr kumimoji="0" lang="nb-NO" sz="8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eV</a:t>
                  </a:r>
                  <a:r>
                    <a:rPr kumimoji="0" lang="nb-NO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] </a:t>
                  </a:r>
                  <a:endPara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4" name="Straight Connector 43"/>
              <p:cNvCxnSpPr/>
              <p:nvPr/>
            </p:nvCxnSpPr>
            <p:spPr>
              <a:xfrm>
                <a:off x="1057452" y="2629815"/>
                <a:ext cx="769602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6271540" y="295200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TextBox 38"/>
            <p:cNvSpPr txBox="1"/>
            <p:nvPr/>
          </p:nvSpPr>
          <p:spPr>
            <a:xfrm>
              <a:off x="3868830" y="372608"/>
              <a:ext cx="56843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Z-bg10</a:t>
              </a:r>
              <a:endPara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965023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92400" y="1083600"/>
            <a:ext cx="6191020" cy="3310509"/>
            <a:chOff x="162000" y="494856"/>
            <a:chExt cx="6191020" cy="3310509"/>
          </a:xfrm>
        </p:grpSpPr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162000" y="494856"/>
              <a:ext cx="6191020" cy="3310509"/>
              <a:chOff x="-115038" y="275224"/>
              <a:chExt cx="10028239" cy="5362376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1026000"/>
                <a:ext cx="3033601" cy="227520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1026000"/>
                <a:ext cx="3033601" cy="22752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9600" y="1026000"/>
                <a:ext cx="3033601" cy="2275200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33624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9600" y="3362400"/>
                <a:ext cx="3033600" cy="2275200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704758" y="639260"/>
                <a:ext cx="3030844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Day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787203" y="641787"/>
                <a:ext cx="3037197" cy="4541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872401" y="639260"/>
                <a:ext cx="3033603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-115038" y="2008613"/>
                <a:ext cx="919482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r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0" y="4347530"/>
                <a:ext cx="804442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B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705598" y="275224"/>
                <a:ext cx="9207599" cy="498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Z-bg20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9600" y="2401200"/>
              <a:ext cx="1872000" cy="1404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093100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658800" y="414000"/>
            <a:ext cx="8425568" cy="5061497"/>
            <a:chOff x="851609" y="659649"/>
            <a:chExt cx="8425568" cy="5061497"/>
          </a:xfrm>
        </p:grpSpPr>
        <p:grpSp>
          <p:nvGrpSpPr>
            <p:cNvPr id="27" name="Group 26"/>
            <p:cNvGrpSpPr/>
            <p:nvPr/>
          </p:nvGrpSpPr>
          <p:grpSpPr>
            <a:xfrm>
              <a:off x="851609" y="1154962"/>
              <a:ext cx="8425568" cy="4566184"/>
              <a:chOff x="327907" y="290438"/>
              <a:chExt cx="8425568" cy="4566184"/>
            </a:xfrm>
          </p:grpSpPr>
          <p:cxnSp>
            <p:nvCxnSpPr>
              <p:cNvPr id="49" name="Straight Connector 48"/>
              <p:cNvCxnSpPr/>
              <p:nvPr/>
            </p:nvCxnSpPr>
            <p:spPr>
              <a:xfrm>
                <a:off x="3842883" y="294648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6271540" y="295200"/>
                <a:ext cx="0" cy="44634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" name="Group 25"/>
              <p:cNvGrpSpPr/>
              <p:nvPr/>
            </p:nvGrpSpPr>
            <p:grpSpPr>
              <a:xfrm>
                <a:off x="327907" y="290438"/>
                <a:ext cx="8425568" cy="4566184"/>
                <a:chOff x="327907" y="290438"/>
                <a:chExt cx="8425568" cy="4566184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1540638" y="290438"/>
                  <a:ext cx="184756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1 </a:t>
                  </a:r>
                  <a:r>
                    <a:rPr kumimoji="0" lang="nb-NO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day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063078" y="324336"/>
                  <a:ext cx="18477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7 </a:t>
                  </a:r>
                  <a:r>
                    <a:rPr kumimoji="0" lang="nb-NO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days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6573850" y="359711"/>
                  <a:ext cx="18505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28 </a:t>
                  </a:r>
                  <a:r>
                    <a:rPr kumimoji="0" lang="nb-NO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days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27907" y="1406133"/>
                  <a:ext cx="65483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Water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442194" y="3367065"/>
                  <a:ext cx="4899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nb-NO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FBS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3" name="Group 12"/>
                <p:cNvGrpSpPr/>
                <p:nvPr/>
              </p:nvGrpSpPr>
              <p:grpSpPr>
                <a:xfrm>
                  <a:off x="1200150" y="630391"/>
                  <a:ext cx="2533652" cy="2079919"/>
                  <a:chOff x="1200150" y="630391"/>
                  <a:chExt cx="2533652" cy="2079919"/>
                </a:xfrm>
              </p:grpSpPr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1200150" y="630391"/>
                    <a:ext cx="2533652" cy="2079919"/>
                    <a:chOff x="1200150" y="630391"/>
                    <a:chExt cx="2533652" cy="2079919"/>
                  </a:xfrm>
                </p:grpSpPr>
                <p:pic>
                  <p:nvPicPr>
                    <p:cNvPr id="8" name="Εικόνα 8" descr="Εικόνα που περιέχει πίνακας&#10;&#10;Περιγραφή που δημιουργήθηκε αυτόματα">
                      <a:extLst>
                        <a:ext uri="{FF2B5EF4-FFF2-40B4-BE49-F238E27FC236}">
                          <a16:creationId xmlns:a16="http://schemas.microsoft.com/office/drawing/2014/main" id="{72732A09-14F7-0AE6-0D9A-6FAA9DEFBDD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t="58775" r="72057" b="252"/>
                    <a:stretch/>
                  </p:blipFill>
                  <p:spPr>
                    <a:xfrm>
                      <a:off x="1200150" y="801015"/>
                      <a:ext cx="2533652" cy="190929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1457745" y="630391"/>
                      <a:ext cx="6229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b-NO" sz="8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ps</a:t>
                      </a:r>
                      <a:r>
                        <a:rPr kumimoji="0" lang="nb-NO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Ev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2793980" y="2391959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4" name="Group 13"/>
                <p:cNvGrpSpPr/>
                <p:nvPr/>
              </p:nvGrpSpPr>
              <p:grpSpPr>
                <a:xfrm>
                  <a:off x="3924300" y="611065"/>
                  <a:ext cx="2124050" cy="2065426"/>
                  <a:chOff x="3924300" y="611065"/>
                  <a:chExt cx="2124050" cy="2065426"/>
                </a:xfrm>
              </p:grpSpPr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3924300" y="611065"/>
                    <a:ext cx="2124050" cy="2065426"/>
                    <a:chOff x="3924300" y="611065"/>
                    <a:chExt cx="2124050" cy="2065426"/>
                  </a:xfrm>
                </p:grpSpPr>
                <p:pic>
                  <p:nvPicPr>
                    <p:cNvPr id="3" name="Εικόνα 6" descr="Εικόνα που περιέχει πίνακας&#10;&#10;Περιγραφή που δημιουργήθηκε αυτόματα">
                      <a:extLst>
                        <a:ext uri="{FF2B5EF4-FFF2-40B4-BE49-F238E27FC236}">
                          <a16:creationId xmlns:a16="http://schemas.microsoft.com/office/drawing/2014/main" id="{D4093D34-5C1A-D63E-15C1-0701BF9C180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/>
                    <a:srcRect l="138" t="50943" r="71745" b="270"/>
                    <a:stretch/>
                  </p:blipFill>
                  <p:spPr>
                    <a:xfrm>
                      <a:off x="3924300" y="759696"/>
                      <a:ext cx="2124050" cy="191679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4134258" y="611065"/>
                      <a:ext cx="6229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b-NO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ps</a:t>
                      </a:r>
                      <a:r>
                        <a:rPr kumimoji="0" lang="nb-NO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Ev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5139180" y="2389932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5" name="Group 14"/>
                <p:cNvGrpSpPr/>
                <p:nvPr/>
              </p:nvGrpSpPr>
              <p:grpSpPr>
                <a:xfrm>
                  <a:off x="6438900" y="614464"/>
                  <a:ext cx="2181228" cy="2095649"/>
                  <a:chOff x="6438900" y="614464"/>
                  <a:chExt cx="2181228" cy="2095649"/>
                </a:xfrm>
              </p:grpSpPr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6438900" y="614464"/>
                    <a:ext cx="2181228" cy="2095649"/>
                    <a:chOff x="6438900" y="614464"/>
                    <a:chExt cx="2181228" cy="2095649"/>
                  </a:xfrm>
                </p:grpSpPr>
                <p:pic>
                  <p:nvPicPr>
                    <p:cNvPr id="10" name="Εικόνα 10" descr="Εικόνα που περιέχει πίνακας&#10;&#10;Περιγραφή που δημιουργήθηκε αυτόματα">
                      <a:extLst>
                        <a:ext uri="{FF2B5EF4-FFF2-40B4-BE49-F238E27FC236}">
                          <a16:creationId xmlns:a16="http://schemas.microsoft.com/office/drawing/2014/main" id="{EF2D7A68-620D-281B-DA67-8B538854878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/>
                    <a:srcRect t="54742" r="74586" b="267"/>
                    <a:stretch/>
                  </p:blipFill>
                  <p:spPr>
                    <a:xfrm>
                      <a:off x="6438900" y="738113"/>
                      <a:ext cx="2181228" cy="1972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6654717" y="614464"/>
                      <a:ext cx="6229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b-NO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ps</a:t>
                      </a:r>
                      <a:r>
                        <a:rPr kumimoji="0" lang="nb-NO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Ev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6" name="TextBox 35"/>
                  <p:cNvSpPr txBox="1"/>
                  <p:nvPr/>
                </p:nvSpPr>
                <p:spPr>
                  <a:xfrm>
                    <a:off x="7707161" y="2396868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6" name="Group 15"/>
                <p:cNvGrpSpPr/>
                <p:nvPr/>
              </p:nvGrpSpPr>
              <p:grpSpPr>
                <a:xfrm>
                  <a:off x="1378460" y="2755881"/>
                  <a:ext cx="2162114" cy="2005380"/>
                  <a:chOff x="1378460" y="2755881"/>
                  <a:chExt cx="2162114" cy="2005380"/>
                </a:xfrm>
              </p:grpSpPr>
              <p:grpSp>
                <p:nvGrpSpPr>
                  <p:cNvPr id="5" name="Group 4"/>
                  <p:cNvGrpSpPr/>
                  <p:nvPr/>
                </p:nvGrpSpPr>
                <p:grpSpPr>
                  <a:xfrm>
                    <a:off x="1378460" y="2755881"/>
                    <a:ext cx="2162114" cy="2005380"/>
                    <a:chOff x="1378460" y="2755881"/>
                    <a:chExt cx="2162114" cy="2005380"/>
                  </a:xfrm>
                </p:grpSpPr>
                <p:pic>
                  <p:nvPicPr>
                    <p:cNvPr id="17" name="Εικόνα 14">
                      <a:extLst>
                        <a:ext uri="{FF2B5EF4-FFF2-40B4-BE49-F238E27FC236}">
                          <a16:creationId xmlns:a16="http://schemas.microsoft.com/office/drawing/2014/main" id="{963411F3-9338-C302-599C-B48F1E2F3D1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/>
                    <a:srcRect t="62592" r="76965" b="168"/>
                    <a:stretch/>
                  </p:blipFill>
                  <p:spPr>
                    <a:xfrm>
                      <a:off x="1378460" y="2943888"/>
                      <a:ext cx="2162114" cy="1817373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1610779" y="2755881"/>
                      <a:ext cx="6229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b-NO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ps</a:t>
                      </a:r>
                      <a:r>
                        <a:rPr kumimoji="0" lang="nb-NO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Ev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2572302" y="4402495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4" name="Group 23"/>
                <p:cNvGrpSpPr/>
                <p:nvPr/>
              </p:nvGrpSpPr>
              <p:grpSpPr>
                <a:xfrm>
                  <a:off x="3927700" y="2699266"/>
                  <a:ext cx="2071026" cy="2080514"/>
                  <a:chOff x="3911752" y="2699266"/>
                  <a:chExt cx="2071026" cy="2080514"/>
                </a:xfrm>
              </p:grpSpPr>
              <p:grpSp>
                <p:nvGrpSpPr>
                  <p:cNvPr id="2" name="Group 1"/>
                  <p:cNvGrpSpPr/>
                  <p:nvPr/>
                </p:nvGrpSpPr>
                <p:grpSpPr>
                  <a:xfrm>
                    <a:off x="3911752" y="2699266"/>
                    <a:ext cx="2071026" cy="2080514"/>
                    <a:chOff x="3971925" y="2683343"/>
                    <a:chExt cx="2071026" cy="2080514"/>
                  </a:xfrm>
                </p:grpSpPr>
                <p:pic>
                  <p:nvPicPr>
                    <p:cNvPr id="9" name="Εικόνα 9" descr="Εικόνα που περιέχει πίνακας&#10;&#10;Περιγραφή που δημιουργήθηκε αυτόματα">
                      <a:extLst>
                        <a:ext uri="{FF2B5EF4-FFF2-40B4-BE49-F238E27FC236}">
                          <a16:creationId xmlns:a16="http://schemas.microsoft.com/office/drawing/2014/main" id="{F29869AF-EAA7-57B5-D8BE-AAA5E628C0C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/>
                    <a:srcRect t="60714" r="77999" b="255"/>
                    <a:stretch/>
                  </p:blipFill>
                  <p:spPr>
                    <a:xfrm>
                      <a:off x="3971925" y="2864721"/>
                      <a:ext cx="2071026" cy="189913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4206581" y="2683343"/>
                      <a:ext cx="6229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b-NO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ps</a:t>
                      </a:r>
                      <a:r>
                        <a:rPr kumimoji="0" lang="nb-NO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Ev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5096543" y="4429723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5" name="Group 24"/>
                <p:cNvGrpSpPr/>
                <p:nvPr/>
              </p:nvGrpSpPr>
              <p:grpSpPr>
                <a:xfrm>
                  <a:off x="6345116" y="2783306"/>
                  <a:ext cx="2355081" cy="2073316"/>
                  <a:chOff x="6345116" y="2783306"/>
                  <a:chExt cx="2355081" cy="2073316"/>
                </a:xfrm>
              </p:grpSpPr>
              <p:pic>
                <p:nvPicPr>
                  <p:cNvPr id="4" name="Εικόνα 4" descr="Εικόνα που περιέχει πίνακας&#10;&#10;Περιγραφή που δημιουργήθηκε αυτόματα">
                    <a:extLst>
                      <a:ext uri="{FF2B5EF4-FFF2-40B4-BE49-F238E27FC236}">
                        <a16:creationId xmlns:a16="http://schemas.microsoft.com/office/drawing/2014/main" id="{8F7DD2CF-FAD4-A30D-EECF-736CC2D9AD7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t="69870" r="79046" b="-260"/>
                  <a:stretch/>
                </p:blipFill>
                <p:spPr>
                  <a:xfrm>
                    <a:off x="6345116" y="2971325"/>
                    <a:ext cx="2355081" cy="1885297"/>
                  </a:xfrm>
                  <a:prstGeom prst="rect">
                    <a:avLst/>
                  </a:prstGeom>
                </p:spPr>
              </p:pic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6642719" y="2783306"/>
                    <a:ext cx="62295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Cps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/Ev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7773723" y="4441112"/>
                    <a:ext cx="8106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Energy [</a:t>
                    </a:r>
                    <a:r>
                      <a:rPr kumimoji="0" lang="nb-NO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keV</a:t>
                    </a:r>
                    <a:r>
                      <a:rPr kumimoji="0" lang="nb-NO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] </a:t>
                    </a:r>
                    <a:endPara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1057452" y="2629815"/>
                  <a:ext cx="769602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3" name="TextBox 42"/>
            <p:cNvSpPr txBox="1"/>
            <p:nvPr/>
          </p:nvSpPr>
          <p:spPr>
            <a:xfrm>
              <a:off x="2699027" y="659649"/>
              <a:ext cx="56843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Z-bg20</a:t>
              </a:r>
              <a:endPara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55938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92400" y="1083600"/>
            <a:ext cx="6177600" cy="3305193"/>
            <a:chOff x="162000" y="494856"/>
            <a:chExt cx="6177600" cy="3305193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7600" y="2395435"/>
              <a:ext cx="1872000" cy="1404000"/>
            </a:xfrm>
            <a:prstGeom prst="rect">
              <a:avLst/>
            </a:prstGeom>
          </p:spPr>
        </p:pic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162000" y="494856"/>
              <a:ext cx="6176794" cy="3305193"/>
              <a:chOff x="-91995" y="283835"/>
              <a:chExt cx="10005196" cy="5353765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33624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90800" y="1026000"/>
                <a:ext cx="3033600" cy="2275200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9600" y="1026000"/>
                <a:ext cx="3033601" cy="2275200"/>
              </a:xfrm>
              <a:prstGeom prst="rect">
                <a:avLst/>
              </a:prstGeom>
            </p:spPr>
          </p:pic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5600" y="3362400"/>
                <a:ext cx="3033600" cy="2275200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705598" y="661560"/>
                <a:ext cx="3030002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Day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787201" y="656061"/>
                <a:ext cx="3037199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6872401" y="673648"/>
                <a:ext cx="3033601" cy="448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 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-91995" y="2008613"/>
                <a:ext cx="896438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r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0" y="4347530"/>
                <a:ext cx="804442" cy="3988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B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05598" y="283835"/>
                <a:ext cx="9207600" cy="498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Z-Ag0.5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42597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867A5ACEDE7C46879FD70367F61781" ma:contentTypeVersion="4" ma:contentTypeDescription="Create a new document." ma:contentTypeScope="" ma:versionID="4725c9e020c5869f28d6a4aa28e35a24">
  <xsd:schema xmlns:xsd="http://www.w3.org/2001/XMLSchema" xmlns:xs="http://www.w3.org/2001/XMLSchema" xmlns:p="http://schemas.microsoft.com/office/2006/metadata/properties" xmlns:ns2="ae4ed773-a29c-4530-bc0b-fc53d9223a14" targetNamespace="http://schemas.microsoft.com/office/2006/metadata/properties" ma:root="true" ma:fieldsID="925b2d4885457ae81849ff362489b00d" ns2:_="">
    <xsd:import namespace="ae4ed773-a29c-4530-bc0b-fc53d9223a1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4ed773-a29c-4530-bc0b-fc53d9223a1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6A781E5-2A59-4333-982C-6FDE8A08024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e4ed773-a29c-4530-bc0b-fc53d9223a1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56EC05A-D84B-495F-A84A-5AF930E8FCB7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ae4ed773-a29c-4530-bc0b-fc53d9223a14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2550710-2E52-404B-A199-714E9C37217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69</TotalTime>
  <Words>352</Words>
  <Application>Microsoft Office PowerPoint</Application>
  <PresentationFormat>Widescreen</PresentationFormat>
  <Paragraphs>131</Paragraphs>
  <Slides>12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Θέμα του Office</vt:lpstr>
      <vt:lpstr>PowerPoint Presentation</vt:lpstr>
      <vt:lpstr>Online Resource 1 Representative scanning electron microgaphs of prototype materials acquired with a mix of back-scatter and secondary electron signal detectors (1500× magnification) after exposure to ultrapure water (water) or Fetal Bovine Serum (FBS) for 1, 7 or 28 day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etet i Os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s Koutroulis</dc:creator>
  <cp:lastModifiedBy>Andreas Koutroulis</cp:lastModifiedBy>
  <cp:revision>65</cp:revision>
  <dcterms:created xsi:type="dcterms:W3CDTF">2021-01-06T16:22:10Z</dcterms:created>
  <dcterms:modified xsi:type="dcterms:W3CDTF">2022-07-19T10:3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867A5ACEDE7C46879FD70367F61781</vt:lpwstr>
  </property>
</Properties>
</file>